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88163" cy="100187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00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144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8532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7949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8321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1117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8550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314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1659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2072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9269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936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4197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AB8CF4-BBF3-44DE-8188-3F564C4527B5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2AAB34-5E4B-4EE6-B2F0-C7CD58DB9F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7970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3.png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5126488" y="1322195"/>
            <a:ext cx="1448564" cy="1442040"/>
            <a:chOff x="1287262" y="915570"/>
            <a:chExt cx="1448564" cy="1442040"/>
          </a:xfrm>
        </p:grpSpPr>
        <p:pic>
          <p:nvPicPr>
            <p:cNvPr id="6" name="Grafik 5"/>
            <p:cNvPicPr>
              <a:picLocks noChangeAspect="1"/>
            </p:cNvPicPr>
            <p:nvPr/>
          </p:nvPicPr>
          <p:blipFill rotWithShape="1">
            <a:blip r:embed="rId3"/>
            <a:srcRect l="5262" b="3876"/>
            <a:stretch/>
          </p:blipFill>
          <p:spPr>
            <a:xfrm>
              <a:off x="1287262" y="915570"/>
              <a:ext cx="1443807" cy="1442040"/>
            </a:xfrm>
            <a:prstGeom prst="rect">
              <a:avLst/>
            </a:prstGeom>
          </p:spPr>
        </p:pic>
        <p:sp>
          <p:nvSpPr>
            <p:cNvPr id="7" name="Textfeld 6"/>
            <p:cNvSpPr txBox="1"/>
            <p:nvPr/>
          </p:nvSpPr>
          <p:spPr>
            <a:xfrm>
              <a:off x="2224147" y="968838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.4%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uppieren 7"/>
          <p:cNvGrpSpPr/>
          <p:nvPr/>
        </p:nvGrpSpPr>
        <p:grpSpPr>
          <a:xfrm>
            <a:off x="5126488" y="3108136"/>
            <a:ext cx="1442207" cy="1442416"/>
            <a:chOff x="5211192" y="1316854"/>
            <a:chExt cx="1442207" cy="1442416"/>
          </a:xfrm>
        </p:grpSpPr>
        <p:pic>
          <p:nvPicPr>
            <p:cNvPr id="9" name="Grafik 8"/>
            <p:cNvPicPr>
              <a:picLocks noChangeAspect="1"/>
            </p:cNvPicPr>
            <p:nvPr/>
          </p:nvPicPr>
          <p:blipFill rotWithShape="1">
            <a:blip r:embed="rId4"/>
            <a:srcRect l="5367" b="3851"/>
            <a:stretch/>
          </p:blipFill>
          <p:spPr>
            <a:xfrm>
              <a:off x="5211192" y="1316854"/>
              <a:ext cx="1442207" cy="1442416"/>
            </a:xfrm>
            <a:prstGeom prst="rect">
              <a:avLst/>
            </a:prstGeom>
          </p:spPr>
        </p:pic>
        <p:sp>
          <p:nvSpPr>
            <p:cNvPr id="10" name="Textfeld 9"/>
            <p:cNvSpPr txBox="1"/>
            <p:nvPr/>
          </p:nvSpPr>
          <p:spPr>
            <a:xfrm>
              <a:off x="6135996" y="1386391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.09%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Textfeld 10"/>
          <p:cNvSpPr txBox="1"/>
          <p:nvPr/>
        </p:nvSpPr>
        <p:spPr>
          <a:xfrm>
            <a:off x="7499" y="7499"/>
            <a:ext cx="274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5655698"/>
              </p:ext>
            </p:extLst>
          </p:nvPr>
        </p:nvGraphicFramePr>
        <p:xfrm>
          <a:off x="1922463" y="1184275"/>
          <a:ext cx="2646362" cy="1716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2" name="Prism 8" r:id="rId5" imgW="3782505" imgH="2453009" progId="Prism8.Document">
                  <p:embed/>
                </p:oleObj>
              </mc:Choice>
              <mc:Fallback>
                <p:oleObj name="Prism 8" r:id="rId5" imgW="3782505" imgH="2453009" progId="Prism8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22463" y="1184275"/>
                        <a:ext cx="2646362" cy="1716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1463718"/>
              </p:ext>
            </p:extLst>
          </p:nvPr>
        </p:nvGraphicFramePr>
        <p:xfrm>
          <a:off x="1966913" y="3052763"/>
          <a:ext cx="2592387" cy="171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3" name="Prism 8" r:id="rId7" imgW="3704716" imgH="2453009" progId="Prism8.Document">
                  <p:embed/>
                </p:oleObj>
              </mc:Choice>
              <mc:Fallback>
                <p:oleObj name="Prism 8" r:id="rId7" imgW="3704716" imgH="2453009" progId="Prism8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66913" y="3052763"/>
                        <a:ext cx="2592387" cy="171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1629619" y="116487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659529" y="116487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629619" y="303165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4659529" y="303165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1694746" y="5111164"/>
            <a:ext cx="524570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hown are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ies of CD4+ T cells (A) with the corresponding gating strategy (B) and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frequencies of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xp3+CD25+CD4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+ T cells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ith the corresponding gating strategy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D) in maternal blood of TD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d PTB patients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mmediat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efor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livery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51631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</Words>
  <Application>Microsoft Office PowerPoint</Application>
  <PresentationFormat>Breitbild</PresentationFormat>
  <Paragraphs>9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8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usse, Mandy</dc:creator>
  <cp:lastModifiedBy>Busse, Mandy</cp:lastModifiedBy>
  <cp:revision>39</cp:revision>
  <cp:lastPrinted>2019-08-27T10:02:58Z</cp:lastPrinted>
  <dcterms:created xsi:type="dcterms:W3CDTF">2019-07-04T11:53:30Z</dcterms:created>
  <dcterms:modified xsi:type="dcterms:W3CDTF">2020-02-07T12:37:36Z</dcterms:modified>
</cp:coreProperties>
</file>